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1" r:id="rId3"/>
    <p:sldId id="269" r:id="rId4"/>
    <p:sldId id="267" r:id="rId5"/>
    <p:sldId id="268" r:id="rId6"/>
    <p:sldId id="266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C7B9C6-780B-4CA9-9F36-AB28158E9115}" v="5" dt="2019-10-27T13:39:06.988"/>
    <p1510:client id="{DA257BA1-1BA8-4698-B2AF-7929A1BA7624}" v="22" dt="2019-10-21T13:41:52.085"/>
    <p1510:client id="{CAF693F4-32EF-4FB3-AFFB-0A7B7517DEA7}" v="4" dt="2019-10-27T12:43:26.8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629"/>
    <p:restoredTop sz="94643"/>
  </p:normalViewPr>
  <p:slideViewPr>
    <p:cSldViewPr snapToGrid="0" snapToObjects="1">
      <p:cViewPr varScale="1">
        <p:scale>
          <a:sx n="80" d="100"/>
          <a:sy n="80" d="100"/>
        </p:scale>
        <p:origin x="1424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CAF693F4-32EF-4FB3-AFFB-0A7B7517DEA7}"/>
    <pc:docChg chg="modSld">
      <pc:chgData name="" userId="" providerId="" clId="Web-{CAF693F4-32EF-4FB3-AFFB-0A7B7517DEA7}" dt="2019-10-27T12:43:26.862" v="2" actId="14100"/>
      <pc:docMkLst>
        <pc:docMk/>
      </pc:docMkLst>
      <pc:sldChg chg="addSp modSp">
        <pc:chgData name="" userId="" providerId="" clId="Web-{CAF693F4-32EF-4FB3-AFFB-0A7B7517DEA7}" dt="2019-10-27T12:43:26.862" v="2" actId="14100"/>
        <pc:sldMkLst>
          <pc:docMk/>
          <pc:sldMk cId="2484581057" sldId="267"/>
        </pc:sldMkLst>
        <pc:picChg chg="add mod">
          <ac:chgData name="" userId="" providerId="" clId="Web-{CAF693F4-32EF-4FB3-AFFB-0A7B7517DEA7}" dt="2019-10-27T12:43:26.862" v="2" actId="14100"/>
          <ac:picMkLst>
            <pc:docMk/>
            <pc:sldMk cId="2484581057" sldId="267"/>
            <ac:picMk id="3" creationId="{A3437376-A191-4353-BB39-20B551333BFF}"/>
          </ac:picMkLst>
        </pc:picChg>
      </pc:sldChg>
    </pc:docChg>
  </pc:docChgLst>
  <pc:docChgLst>
    <pc:chgData clId="Web-{FEC7B9C6-780B-4CA9-9F36-AB28158E9115}"/>
    <pc:docChg chg="modSld">
      <pc:chgData name="" userId="" providerId="" clId="Web-{FEC7B9C6-780B-4CA9-9F36-AB28158E9115}" dt="2019-10-27T13:39:06.988" v="3" actId="14100"/>
      <pc:docMkLst>
        <pc:docMk/>
      </pc:docMkLst>
      <pc:sldChg chg="addSp delSp modSp">
        <pc:chgData name="" userId="" providerId="" clId="Web-{FEC7B9C6-780B-4CA9-9F36-AB28158E9115}" dt="2019-10-27T13:39:06.988" v="3" actId="14100"/>
        <pc:sldMkLst>
          <pc:docMk/>
          <pc:sldMk cId="2484581057" sldId="267"/>
        </pc:sldMkLst>
        <pc:picChg chg="del">
          <ac:chgData name="" userId="" providerId="" clId="Web-{FEC7B9C6-780B-4CA9-9F36-AB28158E9115}" dt="2019-10-27T13:38:35.737" v="0"/>
          <ac:picMkLst>
            <pc:docMk/>
            <pc:sldMk cId="2484581057" sldId="267"/>
            <ac:picMk id="3" creationId="{A3437376-A191-4353-BB39-20B551333BFF}"/>
          </ac:picMkLst>
        </pc:picChg>
        <pc:picChg chg="add mod">
          <ac:chgData name="" userId="" providerId="" clId="Web-{FEC7B9C6-780B-4CA9-9F36-AB28158E9115}" dt="2019-10-27T13:39:06.988" v="3" actId="14100"/>
          <ac:picMkLst>
            <pc:docMk/>
            <pc:sldMk cId="2484581057" sldId="267"/>
            <ac:picMk id="4" creationId="{86E5C630-A72C-4208-9BE2-F89991072222}"/>
          </ac:picMkLst>
        </pc:picChg>
      </pc:sldChg>
    </pc:docChg>
  </pc:docChgLst>
  <pc:docChgLst>
    <pc:chgData clId="Web-{DA257BA1-1BA8-4698-B2AF-7929A1BA7624}"/>
    <pc:docChg chg="addSld modSld sldOrd">
      <pc:chgData name="" userId="" providerId="" clId="Web-{DA257BA1-1BA8-4698-B2AF-7929A1BA7624}" dt="2019-10-21T13:41:52.085" v="20" actId="20577"/>
      <pc:docMkLst>
        <pc:docMk/>
      </pc:docMkLst>
      <pc:sldChg chg="modSp ord">
        <pc:chgData name="" userId="" providerId="" clId="Web-{DA257BA1-1BA8-4698-B2AF-7929A1BA7624}" dt="2019-10-21T13:34:24.681" v="8"/>
        <pc:sldMkLst>
          <pc:docMk/>
          <pc:sldMk cId="1957823701" sldId="266"/>
        </pc:sldMkLst>
        <pc:spChg chg="mod">
          <ac:chgData name="" userId="" providerId="" clId="Web-{DA257BA1-1BA8-4698-B2AF-7929A1BA7624}" dt="2019-10-21T13:33:17.055" v="2" actId="20577"/>
          <ac:spMkLst>
            <pc:docMk/>
            <pc:sldMk cId="1957823701" sldId="266"/>
            <ac:spMk id="2" creationId="{8F2A6CDD-BA74-2543-BEF1-CBBF3B9E95EA}"/>
          </ac:spMkLst>
        </pc:spChg>
      </pc:sldChg>
      <pc:sldChg chg="addSp modSp new ord">
        <pc:chgData name="" userId="" providerId="" clId="Web-{DA257BA1-1BA8-4698-B2AF-7929A1BA7624}" dt="2019-10-21T13:41:52.069" v="19" actId="20577"/>
        <pc:sldMkLst>
          <pc:docMk/>
          <pc:sldMk cId="2484581057" sldId="267"/>
        </pc:sldMkLst>
        <pc:spChg chg="add mod">
          <ac:chgData name="" userId="" providerId="" clId="Web-{DA257BA1-1BA8-4698-B2AF-7929A1BA7624}" dt="2019-10-21T13:41:52.069" v="19" actId="20577"/>
          <ac:spMkLst>
            <pc:docMk/>
            <pc:sldMk cId="2484581057" sldId="267"/>
            <ac:spMk id="2" creationId="{B8A03692-F94A-44A0-BEA3-325C11943FE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E5128-5CCB-7C41-A5EF-D6F7924508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325D9B-CD4C-F94B-BE8B-E25D169A17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DDE9F6-FABC-F540-AE4D-E0FE94A4D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0F4F3B-CF3F-5B4C-AE79-2E5B1C0AF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34352F-66D5-CD4E-9E2A-22AD0AA3A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79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D5C44C-7EAC-AD4E-B510-9445C0B95E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F2EB47-8829-0441-B648-9127CF2BF1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FA5BAF-4140-DA4F-82DE-AF4B4EF75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6F119-A7F9-7342-8938-26330E057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E7837C-4CB5-014D-9F11-375D63428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614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5C7CD0-F745-AE4C-ABAA-FFFE4FCBCC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740617-9368-4542-AD17-D9AFA1ED1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1D2EC-ADBF-2C49-95FC-474DFF952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D4764F-81EA-BE45-944F-716E6340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F5075C-2A21-5B4A-98B8-6D31B318D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55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90C68F-0A5E-7E45-8B98-38D04D134F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770E18-8933-C447-A61A-7DEF00E29C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E3D88A-9687-C04C-8958-E1A911397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1800E5-3578-6047-BDBB-A5C884D13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E8D189-8A66-0F49-878A-8D8B3273B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847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17652-44AA-A546-81E0-7C107DFB5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9675C-B705-BB41-AE95-6EBF1DC2B8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E43F05-622F-3845-B225-FA48EE411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7CC976-8500-7A45-A6C2-00091AE2D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658C6-40C0-7A4A-8703-0E2BCF18A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59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D05E-6429-B045-A2F8-CD729E9AC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505457-DA5B-4E44-BD6D-79DCC3C0CF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FAAB5C-CCBE-074A-A942-9F25FA55A8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153A12-2D59-0B47-87EF-26B9146F7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9E6F18-26EB-DF47-AF6F-5B32A7275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240C3-A97A-E745-BFC0-BC4948FD7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39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26738D-F195-A646-A054-BCDC01C3F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1541EC-0310-904D-BA28-8A6C918D1D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94EC86-7240-D146-8D49-E3DA3D108B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1647BF-DEE2-8545-8CFA-9373D7158F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047A6B-49ED-3B42-99A2-051D4FD6E0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66FB97-956F-154B-B4F9-542BBADC7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6F09DB-7FFB-A74C-9095-3159B547A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A3970B-7DAA-5442-A2FD-8D97F557E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78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9A788-17B4-C249-891E-E33E0B30A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8B39F7-3E07-D347-AC3F-731D725EC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BAB50D-4BA2-8D4E-94FA-2CA272268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540B9C-DCA0-CB43-AE98-A357D5352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075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10507F-0743-EA4B-8B0C-0E0C09B59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6CC211-8A00-A44E-8F4B-32B33364F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0DE921-C285-FE40-B526-05DF59C52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225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90932-0E46-3345-A50B-EDCAC11AF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9BA954-1994-8D41-871B-EAAC84FE73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23A261-8DB1-C645-9317-843D0AC625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80374D-0A14-A345-BE54-A721545A7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7F9783-47AF-E14C-9D57-1B59D29D9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5B5E12-A104-5941-83A4-E2A3108E5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050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A25BA-466D-ED4F-9A29-0652D533F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34CDD8-B4D2-1C4D-8BF0-CB1A7C3FDB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5D89B1-C5B0-F941-B65D-EB85C913F6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53165A-9EF7-2946-A00A-A1A357E7D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E65E9E-34FA-914D-B3F7-D4AE5A2EF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EB0A43-1AB1-EB4B-AF45-523ED309B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494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E0F3B7-2E55-4B44-A79D-A32D74CFD5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08F2B7-19DA-FC4B-814C-2139AB111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B6ACC2-962D-EB40-BB17-ED3FEB9258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1BF57-1417-6A49-894D-5CBC1B3952E9}" type="datetimeFigureOut">
              <a:rPr lang="en-US" smtClean="0"/>
              <a:t>11/1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7E5D99-5DE6-3B4D-A0E5-585A65F598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4B9123-1948-A046-9A51-0513F19702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81082-CE5A-214B-96B6-6FCA6BF95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647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CB73EA8-CA72-DF4A-8C44-8BAA66483F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580916" y="2684396"/>
            <a:ext cx="8368732" cy="478681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-1158365" y="7927882"/>
            <a:ext cx="31137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.1</a:t>
            </a:r>
          </a:p>
        </p:txBody>
      </p:sp>
    </p:spTree>
    <p:extLst>
      <p:ext uri="{BB962C8B-B14F-4D97-AF65-F5344CB8AC3E}">
        <p14:creationId xmlns:p14="http://schemas.microsoft.com/office/powerpoint/2010/main" val="3554184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96" t="22475" r="32703" b="8839"/>
          <a:stretch/>
        </p:blipFill>
        <p:spPr>
          <a:xfrm>
            <a:off x="1642768" y="1860071"/>
            <a:ext cx="2929773" cy="29077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2311A4E-D6DF-9945-AD40-F6D02FF27899}"/>
              </a:ext>
            </a:extLst>
          </p:cNvPr>
          <p:cNvSpPr txBox="1"/>
          <p:nvPr/>
        </p:nvSpPr>
        <p:spPr>
          <a:xfrm>
            <a:off x="38680" y="473396"/>
            <a:ext cx="66560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 –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onsur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apping of conservation from multiple sequence alignment based on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orynebacteria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pecies represented in Fig1.</a:t>
            </a:r>
          </a:p>
        </p:txBody>
      </p:sp>
      <p:pic>
        <p:nvPicPr>
          <p:cNvPr id="5" name="Picture 4" descr="Consurf_expanded_homologues_final_model_orient2_no_sticks.png"/>
          <p:cNvPicPr>
            <a:picLocks noChangeAspect="1"/>
          </p:cNvPicPr>
          <p:nvPr/>
        </p:nvPicPr>
        <p:blipFill>
          <a:blip r:embed="rId3"/>
          <a:srcRect l="15567" r="20053"/>
          <a:stretch>
            <a:fillRect/>
          </a:stretch>
        </p:blipFill>
        <p:spPr>
          <a:xfrm>
            <a:off x="1878071" y="6403261"/>
            <a:ext cx="2744866" cy="290773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2311A4E-D6DF-9945-AD40-F6D02FF27899}"/>
              </a:ext>
            </a:extLst>
          </p:cNvPr>
          <p:cNvSpPr txBox="1"/>
          <p:nvPr/>
        </p:nvSpPr>
        <p:spPr>
          <a:xfrm>
            <a:off x="38680" y="5439107"/>
            <a:ext cx="665603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onsur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apping of conservation from multiple sequence alignment based 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xpanded SDR homologue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ows conservation of the core, but not of the C-terminus and the substrate binding loop.</a:t>
            </a:r>
          </a:p>
        </p:txBody>
      </p:sp>
      <p:sp>
        <p:nvSpPr>
          <p:cNvPr id="7" name="Oval 6"/>
          <p:cNvSpPr/>
          <p:nvPr/>
        </p:nvSpPr>
        <p:spPr>
          <a:xfrm rot="20567451">
            <a:off x="2354036" y="3805019"/>
            <a:ext cx="1792937" cy="651831"/>
          </a:xfrm>
          <a:prstGeom prst="ellipse">
            <a:avLst/>
          </a:prstGeom>
          <a:solidFill>
            <a:srgbClr val="4472C4">
              <a:alpha val="1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 rot="20567451">
            <a:off x="2313611" y="8417739"/>
            <a:ext cx="1792937" cy="651831"/>
          </a:xfrm>
          <a:prstGeom prst="ellipse">
            <a:avLst/>
          </a:prstGeom>
          <a:solidFill>
            <a:srgbClr val="4472C4">
              <a:alpha val="1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327274" y="3923855"/>
            <a:ext cx="14554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Strongly conserve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52767" y="8720584"/>
            <a:ext cx="14554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B0F0"/>
                </a:solidFill>
              </a:rPr>
              <a:t>Highly variable</a:t>
            </a:r>
          </a:p>
        </p:txBody>
      </p:sp>
      <p:sp>
        <p:nvSpPr>
          <p:cNvPr id="11" name="Oval 10"/>
          <p:cNvSpPr/>
          <p:nvPr/>
        </p:nvSpPr>
        <p:spPr>
          <a:xfrm rot="2363054">
            <a:off x="3381482" y="6968800"/>
            <a:ext cx="1140204" cy="594039"/>
          </a:xfrm>
          <a:prstGeom prst="ellipse">
            <a:avLst/>
          </a:prstGeom>
          <a:solidFill>
            <a:srgbClr val="4472C4">
              <a:alpha val="1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539385" y="6512834"/>
            <a:ext cx="11113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B0F0"/>
                </a:solidFill>
              </a:rPr>
              <a:t>Highly variable</a:t>
            </a:r>
          </a:p>
          <a:p>
            <a:r>
              <a:rPr lang="en-US" b="1" dirty="0">
                <a:solidFill>
                  <a:srgbClr val="00B0F0"/>
                </a:solidFill>
              </a:rPr>
              <a:t>substrate loop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572541" y="1860071"/>
            <a:ext cx="145549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Strongly conserved</a:t>
            </a:r>
          </a:p>
          <a:p>
            <a:r>
              <a:rPr lang="en-US" b="1" dirty="0">
                <a:solidFill>
                  <a:srgbClr val="7030A0"/>
                </a:solidFill>
              </a:rPr>
              <a:t>substrate loop</a:t>
            </a:r>
          </a:p>
        </p:txBody>
      </p:sp>
      <p:sp>
        <p:nvSpPr>
          <p:cNvPr id="14" name="Oval 13"/>
          <p:cNvSpPr/>
          <p:nvPr/>
        </p:nvSpPr>
        <p:spPr>
          <a:xfrm rot="2363054">
            <a:off x="3311360" y="2338236"/>
            <a:ext cx="1140204" cy="518924"/>
          </a:xfrm>
          <a:prstGeom prst="ellipse">
            <a:avLst/>
          </a:prstGeom>
          <a:solidFill>
            <a:srgbClr val="4472C4">
              <a:alpha val="1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0" y="146686"/>
            <a:ext cx="2971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.2</a:t>
            </a:r>
          </a:p>
        </p:txBody>
      </p:sp>
    </p:spTree>
    <p:extLst>
      <p:ext uri="{BB962C8B-B14F-4D97-AF65-F5344CB8AC3E}">
        <p14:creationId xmlns:p14="http://schemas.microsoft.com/office/powerpoint/2010/main" val="33013613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F0E5FDB-7542-D349-88D4-8ECF95AB42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4828" y="1472355"/>
            <a:ext cx="6107723" cy="328521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42B75FD-49C2-AC4F-AD37-C8C2D1E8EE2F}"/>
              </a:ext>
            </a:extLst>
          </p:cNvPr>
          <p:cNvSpPr txBox="1"/>
          <p:nvPr/>
        </p:nvSpPr>
        <p:spPr>
          <a:xfrm>
            <a:off x="750320" y="1320735"/>
            <a:ext cx="472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 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2D57D5A-213F-B245-89CC-DDA036CB93E9}"/>
              </a:ext>
            </a:extLst>
          </p:cNvPr>
          <p:cNvSpPr txBox="1"/>
          <p:nvPr/>
        </p:nvSpPr>
        <p:spPr>
          <a:xfrm>
            <a:off x="890998" y="5784379"/>
            <a:ext cx="5556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8AA2713-75D3-BC47-B67C-AFE97691B6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320" y="6502957"/>
            <a:ext cx="5623052" cy="102999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A945BD0-CB88-1B48-99B0-8FF921FBC90C}"/>
              </a:ext>
            </a:extLst>
          </p:cNvPr>
          <p:cNvSpPr txBox="1"/>
          <p:nvPr/>
        </p:nvSpPr>
        <p:spPr>
          <a:xfrm>
            <a:off x="1" y="1"/>
            <a:ext cx="2770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.3</a:t>
            </a:r>
          </a:p>
        </p:txBody>
      </p:sp>
      <p:sp>
        <p:nvSpPr>
          <p:cNvPr id="9" name="Rectangle 8"/>
          <p:cNvSpPr/>
          <p:nvPr/>
        </p:nvSpPr>
        <p:spPr>
          <a:xfrm>
            <a:off x="-22304" y="338555"/>
            <a:ext cx="688030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condary structure prediction for the C-terminal domain of Rv2509 suggests strongly alpha-helical propensity (A) Output from PSIPRED and (B) JPRED4 output incorporating JNET.</a:t>
            </a:r>
          </a:p>
          <a:p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365435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A03692-F94A-44A0-BEA3-325C11943FED}"/>
              </a:ext>
            </a:extLst>
          </p:cNvPr>
          <p:cNvSpPr txBox="1"/>
          <p:nvPr/>
        </p:nvSpPr>
        <p:spPr>
          <a:xfrm>
            <a:off x="308935" y="274995"/>
            <a:ext cx="6349901" cy="98488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600" dirty="0">
                <a:latin typeface="Arial"/>
                <a:cs typeface="Arial"/>
              </a:rPr>
              <a:t>Supporting information Fig.4</a:t>
            </a:r>
          </a:p>
          <a:p>
            <a:pPr algn="just"/>
            <a:r>
              <a:rPr lang="en-US" sz="1400" dirty="0">
                <a:latin typeface="Arial"/>
                <a:cs typeface="Arial"/>
              </a:rPr>
              <a:t>Detection of </a:t>
            </a:r>
            <a:r>
              <a:rPr lang="en-US" sz="1400" i="1" dirty="0">
                <a:latin typeface="Arial"/>
                <a:cs typeface="Arial"/>
              </a:rPr>
              <a:t>Rv2509</a:t>
            </a:r>
            <a:r>
              <a:rPr lang="en-US" sz="1400" dirty="0">
                <a:latin typeface="Arial"/>
                <a:cs typeface="Arial"/>
              </a:rPr>
              <a:t> transcripts in </a:t>
            </a:r>
            <a:r>
              <a:rPr lang="en-US" sz="1400" i="1" dirty="0">
                <a:latin typeface="Arial"/>
                <a:cs typeface="Arial"/>
              </a:rPr>
              <a:t>M. smegmatis </a:t>
            </a:r>
            <a:r>
              <a:rPr lang="en-US" sz="1400" dirty="0">
                <a:latin typeface="Arial"/>
                <a:cs typeface="Arial"/>
              </a:rPr>
              <a:t>strains transformed with C-terminal deletion constructs by RT-PCR. (A) shows products for </a:t>
            </a:r>
            <a:r>
              <a:rPr lang="en-US" sz="1400" i="1" dirty="0">
                <a:latin typeface="Arial"/>
                <a:cs typeface="Arial"/>
              </a:rPr>
              <a:t>Rv2509 </a:t>
            </a:r>
            <a:r>
              <a:rPr lang="en-US" sz="1400" dirty="0">
                <a:latin typeface="Arial"/>
                <a:cs typeface="Arial"/>
              </a:rPr>
              <a:t>while (B) shows products obtained for control (</a:t>
            </a:r>
            <a:r>
              <a:rPr lang="en-US" sz="1400" i="1" dirty="0" err="1">
                <a:latin typeface="Arial"/>
                <a:cs typeface="Arial"/>
              </a:rPr>
              <a:t>sigA</a:t>
            </a:r>
            <a:r>
              <a:rPr lang="en-US" sz="1400" dirty="0">
                <a:latin typeface="Arial"/>
                <a:cs typeface="Arial"/>
              </a:rPr>
              <a:t>).</a:t>
            </a:r>
          </a:p>
        </p:txBody>
      </p:sp>
      <p:pic>
        <p:nvPicPr>
          <p:cNvPr id="4" name="Picture 4" descr="A picture containing black, clock&#10;&#10;Description generated with very high confidence">
            <a:extLst>
              <a:ext uri="{FF2B5EF4-FFF2-40B4-BE49-F238E27FC236}">
                <a16:creationId xmlns:a16="http://schemas.microsoft.com/office/drawing/2014/main" id="{86E5C630-A72C-4208-9BE2-F899910722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87" y="2587894"/>
            <a:ext cx="6287799" cy="3026246"/>
          </a:xfrm>
          <a:prstGeom prst="rect">
            <a:avLst/>
          </a:prstGeom>
        </p:spPr>
      </p:pic>
      <p:sp>
        <p:nvSpPr>
          <p:cNvPr id="5" name="AutoShape 6" descr="data:image/jpg;base64,%20/9j/4AAQSkZJRgABAQEAYABgAAD/2wBDAAUDBAQEAwUEBAQFBQUGBwwIBwcHBw8LCwkMEQ8SEhEPERETFhwXExQaFRERGCEYGh0dHx8fExciJCIeJBweHx7/2wBDAQUFBQcGBw4ICA4eFBEUHh4eHh4eHh4eHh4eHh4eHh4eHh4eHh4eHh4eHh4eHh4eHh4eHh4eHh4eHh4eHh4eHh7/wAARCAEDAG8DASIAAhEBAxEB/8QAHwAAAQUBAQEBAQEAAAAAAAAAAAECAwQFBgcICQoL/8QAtRAAAgEDAwIEAwUFBAQAAAF9AQIDAAQRBRIhMUEGE1FhByJxFDKBkaEII0KxwRVS0fAkM2JyggkKFhcYGRolJicoKSo0NTY3ODk6Q0RFRkdISUpTVFVWV1hZWmNkZWZnaGlqc3R1dnd4eXqDhIWGh4iJipKTlJWWl5iZmqKjpKWmp6ipqrKztLW2t7i5usLDxMXGx8jJytLT1NXW19jZ2uHi4+Tl5ufo6erx8vP09fb3+Pn6/8QAHwEAAwEBAQEBAQEBAQAAAAAAAAECAwQFBgcICQoL/8QAtREAAgECBAQDBAcFBAQAAQJ3AAECAxEEBSExBhJBUQdhcRMiMoEIFEKRobHBCSMzUvAVYnLRChYkNOEl8RcYGRomJygpKjU2Nzg5OkNERUZHSElKU1RVVldYWVpjZGVmZ2hpanN0dXZ3eHl6goOEhYaHiImKkpOUlZaXmJmaoqOkpaanqKmqsrO0tba3uLm6wsPExcbHyMnK0tPU1dbX2Nna4uPk5ebn6Onq8vP09fb3+Pn6/9oADAMBAAIRAxEAPwDpPvKOvWpCvTI49aB0ApyBt2CaAFyvA64pMCmOQJMcd6aHKnqaAJdo3cYpkiZyDjrT0VmzziiTIHGfegCB4dx9PWljhxxjNTRksp6kD2qaJgFK7evegCrsYMT2qSMFjzwuc1KU6gd+ntSr34H1oAgvXCxnZHvB6gVVhdDjb8uR3qwXZi5O373b0qJo/MYnI9sDFADZFUA56+4rPu9iuCqkZ61ouAExk5xwfeqEzKzbW4agDWA2ruP51Ki/xDmmMRwvSlyfUD1xQBBcsPNXPYc1GJF3DGK5Xxtquq2WrxQWNm80bQ7gw9c1g/2p4sY7vsBFAHq1jtYFuvanSJ/CPxrn/AN5qF3Zzm/t2hdWwM9+K6HvkH86AGrFg4wOTT8FeeMdqUMPxpkjgdOcUAO4Y4zSNjaV4pIzn5u9BzgmgCuUQsSeT1pEUjJPc1M0Y3YznNMlyPp2oArzZDAgbhVCWGSW4DBQODk1oSsO2c9qrknccZNAF8qcdzSADbVg8jaRioiAM7TkUAZ16qtdAMuQF60z92w4wR2rC8aaxLpupxRhCUkiyG981j23irEm1gQDQB6NpeBCduBzVplGB2rA8I6nHqCTbP4MZreclY8jqehNAD4XhST95zjtUV5JHMwEa7QO470LEu3PVjycioTFg7gcHtQBPCvJxx6CmyOsfysRmrFqvyqc9vSoCgaV2wG+tADCV+Zi2cdKhlmjZgisM1IYUGBj3qvOo3Zxg9uKAEdTndgGo5Nqj5up9BVshcDuahm+8TjP4UAX/vHnpTGQHvj8KlVT6ZBqQKpYHuKAMDxJp8Fy0XmIrFQRyK5+XQrPPzQD8K6bXJkjePcwBOazJLyHoXWgCXwpY29k8ywjG8AmujZeFB6isLR7iOS6GGHPpW4QzKdrAUAKWxH834VCi5POOKWTcMZ5ApsYOD2XvQBbjGF701FOfm7mnKWbaw4VR0pHfaCB1oACq4IIzVOdfnAFWHMmAMc1EwZh8w5oAiHB5PAqCbG7IJzU0uFVjk4+nSqjTREErkkenegDbkwo78+lEfCliKD83zcf4U4r8u084HFAHl/xb1iTTdRs41bG5Sa89ufE1w0gAkOK77436U17Lp8sQJIyprzdfDl0W3EHFAHWeANfuJ/EdpDvJDHFe2xqxTfgceteKfDHQpIfFEM0gOIwTyK9u+6vHQ9qAIXXge9OWL5A2QecVIq8cDBqQJjHU9hQAxF2rimhec4zU38eOcelG392SoIJPIzQBC3TnIxUbDA6jFTvkEnHHpUTIxXK/hQBTlXqdh/CqBt42HGd1aV2doJzk+grPMrs2FjCmgDeC4wvP1pXGBToueD36UScZ4I44oA5nxZbJcJArKGIY8+lYP8AZyHjYPyrqtYG5VxyQaoCEY5oAh8OWiQ34YAdOwrre3IrE0iMfaMnpW4BxjigAVT/ABD60/ceAVPrntTgp/wpVHy5YHGKAGKfvkHmonmYnCD68d6sxj5V29O+ajxnPy7T6+tAFVmm6Yxn86SXzcctgY7DvViRT/CpY+tIOh6fjQBlMrfMWUmoI42LMFz14OK0X+WRsyDGOOahGzJBb8TQBeDAFevFSOwYfzqsOc88U5PrQBS1RfmXpjPaqg4XtVzVZAGTdx2rOaZP8KANDTNvnc+laqHJ+XjFYunSKz4zzWuh5GTQBYDdMenWhmYKOOM9ahEn7wBSMD0p8jbvvHoaAJcgZPAJqJixY4k49KZJJCqAkg+vFQpNESVRScDsKAJzuHRic9vSomVWJ+Rj6EmomnYPkRH86JJJmTIGM0AK0e1TnYp+lV3aKNsyOHJ7KKkWBiS0hJJ6ZNNNr87d/egCVGBUbRgY54pq444weehpdqhyeuRTCCr7vf0oAxvFFx9nMS7uCe9Ybah83DZAqbx/JJ9ph29Mc1y7yt270Adlot4Gu0HXNdUJMHd/OvMtBuHGoxdQN1ekLgp6jFAEsL8lh61MMMpByeMdagQgD0+lTgKRwpyKAFdFVFGAcVGFXbnAHtUhUMhIPamcMcbjkUALtwMLSg4PPamn5cUx2BGR+FAErFcZ2k0u4Ae/vVCeaQD5FP1J61XwznDyHPoDQBeZt3BGKa33f60dOe/eomagDmfGO3zIt7ce9c44txkbgK1viEJWMJj7GuPMd0WP3hQB0mkLB9siww68Gu9jb5AM8YFeUaGLldSi6n5hnivU4QxhQ8dO9AFtGGOgqYMQp5/OqgD8ZK4qRdzE8jHbigCwDxnsfSkB654qMhRzuFI8gVS24EYoAJJdpPQCopLpfugbj64qrNJ5pyuKSKM7xuPagBZGbJOefSmxnLc8HHFP+XdtKnjqakVUzuXoOuaAJAfl60xiRknNN3Nu4z70vUckmgDF16JZ9uR0rJe0jzwv6Vr6/Ose2sc3iDLFgBQBJY2sa3KNjvXVo21VHtXLWNxG06YIIzXTxDcoNAEy88sf/r1MDwO3FRZCrwMUrOVGRyfSgBZJFXqefSqjF5X6cU50DHc/Sml1HyoCD70AKV8sYWM5o/eMw7YqOSSTIGBimKzMCcEf0oAlLHJ3Pj3pYJGYnLZXtUIPzeoB4zT8KXyM4oAmAOc/5NEpYZwRj9adnEeMgGqtwrcMrN9KAOL+IN/LbvGqbq5I6tcEfdP0rtvFlrHO6+Yv5msEabb9ABwKAK+japM13EDnk16rYNut4z6ivP8AS9NhF3GwA4Ir0O22rEoGRgUASkHA3frTN3P97FNmbJA9aj3lONoAoAdPJ8p5/KoYW3Zb370shLHbg0gxHnof6UAMLMSflAxUckjZAjzk1OmXUblA96NoAJXjNAEEcjZ27SP61IvmHHYDtTki+Y5xT9uzjPFAD3+5UZJPWpQuVDUxlUE+tAHG+MJmjuFHaufF82e+K6/xNZ+eVOOe1YiaUu7GAaADRLlpLyNfeu/jOIgfauN02xWK5RwOhrrhuEYbjOOOaAF8x2IXp7mjv82M9jUWWGD0P51IpLjA/OgBC7Keoz2qNPML7ialWL8TUm0L6ZoAYAdu7k8d6jDNnGMVYDK4x0HrTSqf3qAGRhmbgipEU/xMfrSrtX7opZCAOpH4UAORm2KNnUZ608hSPektvmiX6cVOIi3Kr7UAYesRgAZFZ5RfvcA1b8RSmPcjjBrEiuGPGeBQBdVgsqAZzmtpELxDcx/CuaE3zDufrXSaaN9uCxHI6UABQAlRlifUVNuZRjpQxbJ+X8aMZGRigBQwPVCD65pzxjYW3E0EDPPNKuACOc49aAISNqjDNg9qSMZbLDFKApJ+8KBgHvnPegCcfKvy1GrcksB9KerEds0x23N0oAt23y2yNnnA5qeOZQpRsAZzmqtu6/ZFXvgdaY7AA46UAYPjBvmBU546VzMcuD710XiRfMXvXMvHJxsXgdaAJY5SJ1UjjPfpXbabta0XO0HHGDXERQsZVyuQD6V2OmhVgUjnj8KANE7dnDc/XNNUMec8DtT49ud3FM/5aHpQAP8AdJ5z6CmZOCFY49/Wlb5iecAdamjiTHUk0AQKxA+YE4pC3J+YewpJcKWHLc8VDuXeB0z1oAsK2R6c0meeO1NUDHy9O1BBA6jJoAsR7VUDsBimP1O1j9PSkWXK8KD+NMaVslSgAoAp6nD5qcjNY32Rtwwvfua35VRxksR7Zqs8O5h6elAGatsyMCygD0rZjIWJVznFQlVxgrzUq8Jycj0oAtLJgjpSvhjw3OO1VYyRnpyatEjAPGRQAjnadoz70JLIFI9BikYMcncN1R7Xz1wBQAhbIweuaQbd/JxU21hyGBPvTXK4yQOOpoAYrbGwxB54xTzl8noM1AUZpPlyPSnBjnaTk+1AD4VKRbevvSfMufl5PfNLuwoHrUbmRsjAx2OaAHnt0460hO45ONuKYzP95Rg03LhduCT60ARHzBPIGZfLONgA5Hrk1JuG3rn0pjBi3zHNOwuzGM/SgBU5IHv1q1taNh82frVRSABwQKniYnufzoAkduTxTA5wCy5p/wA3Q/nTcc8HigBCze/rinAZH/1qcsYLdyadI0SD94wGOgFAEQjyd2c1KqxRkliM1n3V9KVKWybc/wARFUjazOoa4nZ3784z+VAGknSh+DuHWiigBsDs2dxzT/4j9KKKAGryOeaGAGCPSiigBB1NOjJx+NFFAD8nd1PSn9h9RRRQBNcsVgBXg4rIdmbqSaKKAD27UHr+FFFAH//Z"/>
          <p:cNvSpPr>
            <a:spLocks noChangeAspect="1" noChangeArrowheads="1"/>
          </p:cNvSpPr>
          <p:nvPr/>
        </p:nvSpPr>
        <p:spPr bwMode="auto">
          <a:xfrm>
            <a:off x="728223" y="2485714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AutoShape 6" descr="data:image/jpg;base64,%20/9j/4AAQSkZJRgABAQEAYABgAAD/2wBDAAUDBAQEAwUEBAQFBQUGBwwIBwcHBw8LCwkMEQ8SEhEPERETFhwXExQaFRERGCEYGh0dHx8fExciJCIeJBweHx7/2wBDAQUFBQcGBw4ICA4eFBEUHh4eHh4eHh4eHh4eHh4eHh4eHh4eHh4eHh4eHh4eHh4eHh4eHh4eHh4eHh4eHh4eHh7/wAARCAEDAG8DASIAAhEBAxEB/8QAHwAAAQUBAQEBAQEAAAAAAAAAAAECAwQFBgcICQoL/8QAtRAAAgEDAwIEAwUFBAQAAAF9AQIDAAQRBRIhMUEGE1FhByJxFDKBkaEII0KxwRVS0fAkM2JyggkKFhcYGRolJicoKSo0NTY3ODk6Q0RFRkdISUpTVFVWV1hZWmNkZWZnaGlqc3R1dnd4eXqDhIWGh4iJipKTlJWWl5iZmqKjpKWmp6ipqrKztLW2t7i5usLDxMXGx8jJytLT1NXW19jZ2uHi4+Tl5ufo6erx8vP09fb3+Pn6/8QAHwEAAwEBAQEBAQEBAQAAAAAAAAECAwQFBgcICQoL/8QAtREAAgECBAQDBAcFBAQAAQJ3AAECAxEEBSExBhJBUQdhcRMiMoEIFEKRobHBCSMzUvAVYnLRChYkNOEl8RcYGRomJygpKjU2Nzg5OkNERUZHSElKU1RVVldYWVpjZGVmZ2hpanN0dXZ3eHl6goOEhYaHiImKkpOUlZaXmJmaoqOkpaanqKmqsrO0tba3uLm6wsPExcbHyMnK0tPU1dbX2Nna4uPk5ebn6Onq8vP09fb3+Pn6/9oADAMBAAIRAxEAPwDpPvKOvWpCvTI49aB0ApyBt2CaAFyvA64pMCmOQJMcd6aHKnqaAJdo3cYpkiZyDjrT0VmzziiTIHGfegCB4dx9PWljhxxjNTRksp6kD2qaJgFK7evegCrsYMT2qSMFjzwuc1KU6gd+ntSr34H1oAgvXCxnZHvB6gVVhdDjb8uR3qwXZi5O373b0qJo/MYnI9sDFADZFUA56+4rPu9iuCqkZ61ouAExk5xwfeqEzKzbW4agDWA2ruP51Ki/xDmmMRwvSlyfUD1xQBBcsPNXPYc1GJF3DGK5Xxtquq2WrxQWNm80bQ7gw9c1g/2p4sY7vsBFAHq1jtYFuvanSJ/CPxrn/AN5qF3Zzm/t2hdWwM9+K6HvkH86AGrFg4wOTT8FeeMdqUMPxpkjgdOcUAO4Y4zSNjaV4pIzn5u9BzgmgCuUQsSeT1pEUjJPc1M0Y3YznNMlyPp2oArzZDAgbhVCWGSW4DBQODk1oSsO2c9qrknccZNAF8qcdzSADbVg8jaRioiAM7TkUAZ16qtdAMuQF60z92w4wR2rC8aaxLpupxRhCUkiyG981j23irEm1gQDQB6NpeBCduBzVplGB2rA8I6nHqCTbP4MZreclY8jqehNAD4XhST95zjtUV5JHMwEa7QO470LEu3PVjycioTFg7gcHtQBPCvJxx6CmyOsfysRmrFqvyqc9vSoCgaV2wG+tADCV+Zi2cdKhlmjZgisM1IYUGBj3qvOo3Zxg9uKAEdTndgGo5Nqj5up9BVshcDuahm+8TjP4UAX/vHnpTGQHvj8KlVT6ZBqQKpYHuKAMDxJp8Fy0XmIrFQRyK5+XQrPPzQD8K6bXJkjePcwBOazJLyHoXWgCXwpY29k8ywjG8AmujZeFB6isLR7iOS6GGHPpW4QzKdrAUAKWxH834VCi5POOKWTcMZ5ApsYOD2XvQBbjGF701FOfm7mnKWbaw4VR0pHfaCB1oACq4IIzVOdfnAFWHMmAMc1EwZh8w5oAiHB5PAqCbG7IJzU0uFVjk4+nSqjTREErkkenegDbkwo78+lEfCliKD83zcf4U4r8u084HFAHl/xb1iTTdRs41bG5Sa89ufE1w0gAkOK77436U17Lp8sQJIyprzdfDl0W3EHFAHWeANfuJ/EdpDvJDHFe2xqxTfgceteKfDHQpIfFEM0gOIwTyK9u+6vHQ9qAIXXge9OWL5A2QecVIq8cDBqQJjHU9hQAxF2rimhec4zU38eOcelG392SoIJPIzQBC3TnIxUbDA6jFTvkEnHHpUTIxXK/hQBTlXqdh/CqBt42HGd1aV2doJzk+grPMrs2FjCmgDeC4wvP1pXGBToueD36UScZ4I44oA5nxZbJcJArKGIY8+lYP8AZyHjYPyrqtYG5VxyQaoCEY5oAh8OWiQ34YAdOwrre3IrE0iMfaMnpW4BxjigAVT/ABD60/ceAVPrntTgp/wpVHy5YHGKAGKfvkHmonmYnCD68d6sxj5V29O+ajxnPy7T6+tAFVmm6Yxn86SXzcctgY7DvViRT/CpY+tIOh6fjQBlMrfMWUmoI42LMFz14OK0X+WRsyDGOOahGzJBb8TQBeDAFevFSOwYfzqsOc88U5PrQBS1RfmXpjPaqg4XtVzVZAGTdx2rOaZP8KANDTNvnc+laqHJ+XjFYunSKz4zzWuh5GTQBYDdMenWhmYKOOM9ahEn7wBSMD0p8jbvvHoaAJcgZPAJqJixY4k49KZJJCqAkg+vFQpNESVRScDsKAJzuHRic9vSomVWJ+Rj6EmomnYPkRH86JJJmTIGM0AK0e1TnYp+lV3aKNsyOHJ7KKkWBiS0hJJ6ZNNNr87d/egCVGBUbRgY54pq444weehpdqhyeuRTCCr7vf0oAxvFFx9nMS7uCe9Ybah83DZAqbx/JJ9ph29Mc1y7yt270Adlot4Gu0HXNdUJMHd/OvMtBuHGoxdQN1ekLgp6jFAEsL8lh61MMMpByeMdagQgD0+lTgKRwpyKAFdFVFGAcVGFXbnAHtUhUMhIPamcMcbjkUALtwMLSg4PPamn5cUx2BGR+FAErFcZ2k0u4Ae/vVCeaQD5FP1J61XwznDyHPoDQBeZt3BGKa33f60dOe/eomagDmfGO3zIt7ce9c44txkbgK1viEJWMJj7GuPMd0WP3hQB0mkLB9siww68Gu9jb5AM8YFeUaGLldSi6n5hnivU4QxhQ8dO9AFtGGOgqYMQp5/OqgD8ZK4qRdzE8jHbigCwDxnsfSkB654qMhRzuFI8gVS24EYoAJJdpPQCopLpfugbj64qrNJ5pyuKSKM7xuPagBZGbJOefSmxnLc8HHFP+XdtKnjqakVUzuXoOuaAJAfl60xiRknNN3Nu4z70vUckmgDF16JZ9uR0rJe0jzwv6Vr6/Ose2sc3iDLFgBQBJY2sa3KNjvXVo21VHtXLWNxG06YIIzXTxDcoNAEy88sf/r1MDwO3FRZCrwMUrOVGRyfSgBZJFXqefSqjF5X6cU50DHc/Sml1HyoCD70AKV8sYWM5o/eMw7YqOSSTIGBimKzMCcEf0oAlLHJ3Pj3pYJGYnLZXtUIPzeoB4zT8KXyM4oAmAOc/5NEpYZwRj9adnEeMgGqtwrcMrN9KAOL+IN/LbvGqbq5I6tcEfdP0rtvFlrHO6+Yv5msEabb9ABwKAK+japM13EDnk16rYNut4z6ivP8AS9NhF3GwA4Ir0O22rEoGRgUASkHA3frTN3P97FNmbJA9aj3lONoAoAdPJ8p5/KoYW3Zb370shLHbg0gxHnof6UAMLMSflAxUckjZAjzk1OmXUblA96NoAJXjNAEEcjZ27SP61IvmHHYDtTki+Y5xT9uzjPFAD3+5UZJPWpQuVDUxlUE+tAHG+MJmjuFHaufF82e+K6/xNZ+eVOOe1YiaUu7GAaADRLlpLyNfeu/jOIgfauN02xWK5RwOhrrhuEYbjOOOaAF8x2IXp7mjv82M9jUWWGD0P51IpLjA/OgBC7Keoz2qNPML7ialWL8TUm0L6ZoAYAdu7k8d6jDNnGMVYDK4x0HrTSqf3qAGRhmbgipEU/xMfrSrtX7opZCAOpH4UAORm2KNnUZ608hSPektvmiX6cVOIi3Kr7UAYesRgAZFZ5RfvcA1b8RSmPcjjBrEiuGPGeBQBdVgsqAZzmtpELxDcx/CuaE3zDufrXSaaN9uCxHI6UABQAlRlifUVNuZRjpQxbJ+X8aMZGRigBQwPVCD65pzxjYW3E0EDPPNKuACOc49aAISNqjDNg9qSMZbLDFKApJ+8KBgHvnPegCcfKvy1GrcksB9KerEds0x23N0oAt23y2yNnnA5qeOZQpRsAZzmqtu6/ZFXvgdaY7AA46UAYPjBvmBU546VzMcuD710XiRfMXvXMvHJxsXgdaAJY5SJ1UjjPfpXbabta0XO0HHGDXERQsZVyuQD6V2OmhVgUjnj8KANE7dnDc/XNNUMec8DtT49ud3FM/5aHpQAP8AdJ5z6CmZOCFY49/Wlb5iecAdamjiTHUk0AQKxA+YE4pC3J+YewpJcKWHLc8VDuXeB0z1oAsK2R6c0meeO1NUDHy9O1BBA6jJoAsR7VUDsBimP1O1j9PSkWXK8KD+NMaVslSgAoAp6nD5qcjNY32Rtwwvfua35VRxksR7Zqs8O5h6elAGatsyMCygD0rZjIWJVznFQlVxgrzUq8Jycj0oAtLJgjpSvhjw3OO1VYyRnpyatEjAPGRQAjnadoz70JLIFI9BikYMcncN1R7Xz1wBQAhbIweuaQbd/JxU21hyGBPvTXK4yQOOpoAYrbGwxB54xTzl8noM1AUZpPlyPSnBjnaTk+1AD4VKRbevvSfMufl5PfNLuwoHrUbmRsjAx2OaAHnt0460hO45ONuKYzP95Rg03LhduCT60ARHzBPIGZfLONgA5Hrk1JuG3rn0pjBi3zHNOwuzGM/SgBU5IHv1q1taNh82frVRSABwQKniYnufzoAkduTxTA5wCy5p/wA3Q/nTcc8HigBCze/rinAZH/1qcsYLdyadI0SD94wGOgFAEQjyd2c1KqxRkliM1n3V9KVKWybc/wARFUjazOoa4nZ3784z+VAGknSh+DuHWiigBsDs2dxzT/4j9KKKAGryOeaGAGCPSiigBB1NOjJx+NFFAD8nd1PSn9h9RRRQBNcsVgBXg4rIdmbqSaKKAD27UHr+FFFAH//Z"/>
          <p:cNvSpPr>
            <a:spLocks noChangeAspect="1" noChangeArrowheads="1"/>
          </p:cNvSpPr>
          <p:nvPr/>
        </p:nvSpPr>
        <p:spPr bwMode="auto">
          <a:xfrm>
            <a:off x="3597989" y="250266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84581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3505" y="3536946"/>
            <a:ext cx="1171575" cy="210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AutoShape 4" descr="data:image/jpg;base64,%20/9j/4AAQSkZJRgABAQEAYABgAAD/2wBDAAUDBAQEAwUEBAQFBQUGBwwIBwcHBw8LCwkMEQ8SEhEPERETFhwXExQaFRERGCEYGh0dHx8fExciJCIeJBweHx7/2wBDAQUFBQcGBw4ICA4eFBEUHh4eHh4eHh4eHh4eHh4eHh4eHh4eHh4eHh4eHh4eHh4eHh4eHh4eHh4eHh4eHh4eHh7/wAARCAEDAG8DASIAAhEBAxEB/8QAHwAAAQUBAQEBAQEAAAAAAAAAAAECAwQFBgcICQoL/8QAtRAAAgEDAwIEAwUFBAQAAAF9AQIDAAQRBRIhMUEGE1FhByJxFDKBkaEII0KxwRVS0fAkM2JyggkKFhcYGRolJicoKSo0NTY3ODk6Q0RFRkdISUpTVFVWV1hZWmNkZWZnaGlqc3R1dnd4eXqDhIWGh4iJipKTlJWWl5iZmqKjpKWmp6ipqrKztLW2t7i5usLDxMXGx8jJytLT1NXW19jZ2uHi4+Tl5ufo6erx8vP09fb3+Pn6/8QAHwEAAwEBAQEBAQEBAQAAAAAAAAECAwQFBgcICQoL/8QAtREAAgECBAQDBAcFBAQAAQJ3AAECAxEEBSExBhJBUQdhcRMiMoEIFEKRobHBCSMzUvAVYnLRChYkNOEl8RcYGRomJygpKjU2Nzg5OkNERUZHSElKU1RVVldYWVpjZGVmZ2hpanN0dXZ3eHl6goOEhYaHiImKkpOUlZaXmJmaoqOkpaanqKmqsrO0tba3uLm6wsPExcbHyMnK0tPU1dbX2Nna4uPk5ebn6Onq8vP09fb3+Pn6/9oADAMBAAIRAxEAPwDpPvKOvWpCvTI49aB0ApyBt2CaAFyvA64pMCmOQJMcd6aHKnqaAJdo3cYpkiZyDjrT0VmzziiTIHGfegCB4dx9PWljhxxjNTRksp6kD2qaJgFK7evegCrsYMT2qSMFjzwuc1KU6gd+ntSr34H1oAgvXCxnZHvB6gVVhdDjb8uR3qwXZi5O373b0qJo/MYnI9sDFADZFUA56+4rPu9iuCqkZ61ouAExk5xwfeqEzKzbW4agDWA2ruP51Ki/xDmmMRwvSlyfUD1xQBBcsPNXPYc1GJF3DGK5Xxtquq2WrxQWNm80bQ7gw9c1g/2p4sY7vsBFAHq1jtYFuvanSJ/CPxrn/AN5qF3Zzm/t2hdWwM9+K6HvkH86AGrFg4wOTT8FeeMdqUMPxpkjgdOcUAO4Y4zSNjaV4pIzn5u9BzgmgCuUQsSeT1pEUjJPc1M0Y3YznNMlyPp2oArzZDAgbhVCWGSW4DBQODk1oSsO2c9qrknccZNAF8qcdzSADbVg8jaRioiAM7TkUAZ16qtdAMuQF60z92w4wR2rC8aaxLpupxRhCUkiyG981j23irEm1gQDQB6NpeBCduBzVplGB2rA8I6nHqCTbP4MZreclY8jqehNAD4XhST95zjtUV5JHMwEa7QO470LEu3PVjycioTFg7gcHtQBPCvJxx6CmyOsfysRmrFqvyqc9vSoCgaV2wG+tADCV+Zi2cdKhlmjZgisM1IYUGBj3qvOo3Zxg9uKAEdTndgGo5Nqj5up9BVshcDuahm+8TjP4UAX/vHnpTGQHvj8KlVT6ZBqQKpYHuKAMDxJp8Fy0XmIrFQRyK5+XQrPPzQD8K6bXJkjePcwBOazJLyHoXWgCXwpY29k8ywjG8AmujZeFB6isLR7iOS6GGHPpW4QzKdrAUAKWxH834VCi5POOKWTcMZ5ApsYOD2XvQBbjGF701FOfm7mnKWbaw4VR0pHfaCB1oACq4IIzVOdfnAFWHMmAMc1EwZh8w5oAiHB5PAqCbG7IJzU0uFVjk4+nSqjTREErkkenegDbkwo78+lEfCliKD83zcf4U4r8u084HFAHl/xb1iTTdRs41bG5Sa89ufE1w0gAkOK77436U17Lp8sQJIyprzdfDl0W3EHFAHWeANfuJ/EdpDvJDHFe2xqxTfgceteKfDHQpIfFEM0gOIwTyK9u+6vHQ9qAIXXge9OWL5A2QecVIq8cDBqQJjHU9hQAxF2rimhec4zU38eOcelG392SoIJPIzQBC3TnIxUbDA6jFTvkEnHHpUTIxXK/hQBTlXqdh/CqBt42HGd1aV2doJzk+grPMrs2FjCmgDeC4wvP1pXGBToueD36UScZ4I44oA5nxZbJcJArKGIY8+lYP8AZyHjYPyrqtYG5VxyQaoCEY5oAh8OWiQ34YAdOwrre3IrE0iMfaMnpW4BxjigAVT/ABD60/ceAVPrntTgp/wpVHy5YHGKAGKfvkHmonmYnCD68d6sxj5V29O+ajxnPy7T6+tAFVmm6Yxn86SXzcctgY7DvViRT/CpY+tIOh6fjQBlMrfMWUmoI42LMFz14OK0X+WRsyDGOOahGzJBb8TQBeDAFevFSOwYfzqsOc88U5PrQBS1RfmXpjPaqg4XtVzVZAGTdx2rOaZP8KANDTNvnc+laqHJ+XjFYunSKz4zzWuh5GTQBYDdMenWhmYKOOM9ahEn7wBSMD0p8jbvvHoaAJcgZPAJqJixY4k49KZJJCqAkg+vFQpNESVRScDsKAJzuHRic9vSomVWJ+Rj6EmomnYPkRH86JJJmTIGM0AK0e1TnYp+lV3aKNsyOHJ7KKkWBiS0hJJ6ZNNNr87d/egCVGBUbRgY54pq444weehpdqhyeuRTCCr7vf0oAxvFFx9nMS7uCe9Ybah83DZAqbx/JJ9ph29Mc1y7yt270Adlot4Gu0HXNdUJMHd/OvMtBuHGoxdQN1ekLgp6jFAEsL8lh61MMMpByeMdagQgD0+lTgKRwpyKAFdFVFGAcVGFXbnAHtUhUMhIPamcMcbjkUALtwMLSg4PPamn5cUx2BGR+FAErFcZ2k0u4Ae/vVCeaQD5FP1J61XwznDyHPoDQBeZt3BGKa33f60dOe/eomagDmfGO3zIt7ce9c44txkbgK1viEJWMJj7GuPMd0WP3hQB0mkLB9siww68Gu9jb5AM8YFeUaGLldSi6n5hnivU4QxhQ8dO9AFtGGOgqYMQp5/OqgD8ZK4qRdzE8jHbigCwDxnsfSkB654qMhRzuFI8gVS24EYoAJJdpPQCopLpfugbj64qrNJ5pyuKSKM7xuPagBZGbJOefSmxnLc8HHFP+XdtKnjqakVUzuXoOuaAJAfl60xiRknNN3Nu4z70vUckmgDF16JZ9uR0rJe0jzwv6Vr6/Ose2sc3iDLFgBQBJY2sa3KNjvXVo21VHtXLWNxG06YIIzXTxDcoNAEy88sf/r1MDwO3FRZCrwMUrOVGRyfSgBZJFXqefSqjF5X6cU50DHc/Sml1HyoCD70AKV8sYWM5o/eMw7YqOSSTIGBimKzMCcEf0oAlLHJ3Pj3pYJGYnLZXtUIPzeoB4zT8KXyM4oAmAOc/5NEpYZwRj9adnEeMgGqtwrcMrN9KAOL+IN/LbvGqbq5I6tcEfdP0rtvFlrHO6+Yv5msEabb9ABwKAK+japM13EDnk16rYNut4z6ivP8AS9NhF3GwA4Ir0O22rEoGRgUASkHA3frTN3P97FNmbJA9aj3lONoAoAdPJ8p5/KoYW3Zb370shLHbg0gxHnof6UAMLMSflAxUckjZAjzk1OmXUblA96NoAJXjNAEEcjZ27SP61IvmHHYDtTki+Y5xT9uzjPFAD3+5UZJPWpQuVDUxlUE+tAHG+MJmjuFHaufF82e+K6/xNZ+eVOOe1YiaUu7GAaADRLlpLyNfeu/jOIgfauN02xWK5RwOhrrhuEYbjOOOaAF8x2IXp7mjv82M9jUWWGD0P51IpLjA/OgBC7Keoz2qNPML7ialWL8TUm0L6ZoAYAdu7k8d6jDNnGMVYDK4x0HrTSqf3qAGRhmbgipEU/xMfrSrtX7opZCAOpH4UAORm2KNnUZ608hSPektvmiX6cVOIi3Kr7UAYesRgAZFZ5RfvcA1b8RSmPcjjBrEiuGPGeBQBdVgsqAZzmtpELxDcx/CuaE3zDufrXSaaN9uCxHI6UABQAlRlifUVNuZRjpQxbJ+X8aMZGRigBQwPVCD65pzxjYW3E0EDPPNKuACOc49aAISNqjDNg9qSMZbLDFKApJ+8KBgHvnPegCcfKvy1GrcksB9KerEds0x23N0oAt23y2yNnnA5qeOZQpRsAZzmqtu6/ZFXvgdaY7AA46UAYPjBvmBU546VzMcuD710XiRfMXvXMvHJxsXgdaAJY5SJ1UjjPfpXbabta0XO0HHGDXERQsZVyuQD6V2OmhVgUjnj8KANE7dnDc/XNNUMec8DtT49ud3FM/5aHpQAP8AdJ5z6CmZOCFY49/Wlb5iecAdamjiTHUk0AQKxA+YE4pC3J+YewpJcKWHLc8VDuXeB0z1oAsK2R6c0meeO1NUDHy9O1BBA6jJoAsR7VUDsBimP1O1j9PSkWXK8KD+NMaVslSgAoAp6nD5qcjNY32Rtwwvfua35VRxksR7Zqs8O5h6elAGatsyMCygD0rZjIWJVznFQlVxgrzUq8Jycj0oAtLJgjpSvhjw3OO1VYyRnpyatEjAPGRQAjnadoz70JLIFI9BikYMcncN1R7Xz1wBQAhbIweuaQbd/JxU21hyGBPvTXK4yQOOpoAYrbGwxB54xTzl8noM1AUZpPlyPSnBjnaTk+1AD4VKRbevvSfMufl5PfNLuwoHrUbmRsjAx2OaAHnt0460hO45ONuKYzP95Rg03LhduCT60ARHzBPIGZfLONgA5Hrk1JuG3rn0pjBi3zHNOwuzGM/SgBU5IHv1q1taNh82frVRSABwQKniYnufzoAkduTxTA5wCy5p/wA3Q/nTcc8HigBCze/rinAZH/1qcsYLdyadI0SD94wGOgFAEQjyd2c1KqxRkliM1n3V9KVKWybc/wARFUjazOoa4nZ3784z+VAGknSh+DuHWiigBsDs2dxzT/4j9KKKAGryOeaGAGCPSiigBB1NOjJx+NFFAD8nd1PSn9h9RRRQBNcsVgBXg4rIdmbqSaKKAD27UHr+FFFAH//Z"/>
          <p:cNvSpPr>
            <a:spLocks noChangeAspect="1" noChangeArrowheads="1"/>
          </p:cNvSpPr>
          <p:nvPr/>
        </p:nvSpPr>
        <p:spPr bwMode="auto">
          <a:xfrm>
            <a:off x="21272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AutoShape 6" descr="data:image/jpg;base64,%20/9j/4AAQSkZJRgABAQEAYABgAAD/2wBDAAUDBAQEAwUEBAQFBQUGBwwIBwcHBw8LCwkMEQ8SEhEPERETFhwXExQaFRERGCEYGh0dHx8fExciJCIeJBweHx7/2wBDAQUFBQcGBw4ICA4eFBEUHh4eHh4eHh4eHh4eHh4eHh4eHh4eHh4eHh4eHh4eHh4eHh4eHh4eHh4eHh4eHh4eHh7/wAARCAEDAG8DASIAAhEBAxEB/8QAHwAAAQUBAQEBAQEAAAAAAAAAAAECAwQFBgcICQoL/8QAtRAAAgEDAwIEAwUFBAQAAAF9AQIDAAQRBRIhMUEGE1FhByJxFDKBkaEII0KxwRVS0fAkM2JyggkKFhcYGRolJicoKSo0NTY3ODk6Q0RFRkdISUpTVFVWV1hZWmNkZWZnaGlqc3R1dnd4eXqDhIWGh4iJipKTlJWWl5iZmqKjpKWmp6ipqrKztLW2t7i5usLDxMXGx8jJytLT1NXW19jZ2uHi4+Tl5ufo6erx8vP09fb3+Pn6/8QAHwEAAwEBAQEBAQEBAQAAAAAAAAECAwQFBgcICQoL/8QAtREAAgECBAQDBAcFBAQAAQJ3AAECAxEEBSExBhJBUQdhcRMiMoEIFEKRobHBCSMzUvAVYnLRChYkNOEl8RcYGRomJygpKjU2Nzg5OkNERUZHSElKU1RVVldYWVpjZGVmZ2hpanN0dXZ3eHl6goOEhYaHiImKkpOUlZaXmJmaoqOkpaanqKmqsrO0tba3uLm6wsPExcbHyMnK0tPU1dbX2Nna4uPk5ebn6Onq8vP09fb3+Pn6/9oADAMBAAIRAxEAPwDpPvKOvWpCvTI49aB0ApyBt2CaAFyvA64pMCmOQJMcd6aHKnqaAJdo3cYpkiZyDjrT0VmzziiTIHGfegCB4dx9PWljhxxjNTRksp6kD2qaJgFK7evegCrsYMT2qSMFjzwuc1KU6gd+ntSr34H1oAgvXCxnZHvB6gVVhdDjb8uR3qwXZi5O373b0qJo/MYnI9sDFADZFUA56+4rPu9iuCqkZ61ouAExk5xwfeqEzKzbW4agDWA2ruP51Ki/xDmmMRwvSlyfUD1xQBBcsPNXPYc1GJF3DGK5Xxtquq2WrxQWNm80bQ7gw9c1g/2p4sY7vsBFAHq1jtYFuvanSJ/CPxrn/AN5qF3Zzm/t2hdWwM9+K6HvkH86AGrFg4wOTT8FeeMdqUMPxpkjgdOcUAO4Y4zSNjaV4pIzn5u9BzgmgCuUQsSeT1pEUjJPc1M0Y3YznNMlyPp2oArzZDAgbhVCWGSW4DBQODk1oSsO2c9qrknccZNAF8qcdzSADbVg8jaRioiAM7TkUAZ16qtdAMuQF60z92w4wR2rC8aaxLpupxRhCUkiyG981j23irEm1gQDQB6NpeBCduBzVplGB2rA8I6nHqCTbP4MZreclY8jqehNAD4XhST95zjtUV5JHMwEa7QO470LEu3PVjycioTFg7gcHtQBPCvJxx6CmyOsfysRmrFqvyqc9vSoCgaV2wG+tADCV+Zi2cdKhlmjZgisM1IYUGBj3qvOo3Zxg9uKAEdTndgGo5Nqj5up9BVshcDuahm+8TjP4UAX/vHnpTGQHvj8KlVT6ZBqQKpYHuKAMDxJp8Fy0XmIrFQRyK5+XQrPPzQD8K6bXJkjePcwBOazJLyHoXWgCXwpY29k8ywjG8AmujZeFB6isLR7iOS6GGHPpW4QzKdrAUAKWxH834VCi5POOKWTcMZ5ApsYOD2XvQBbjGF701FOfm7mnKWbaw4VR0pHfaCB1oACq4IIzVOdfnAFWHMmAMc1EwZh8w5oAiHB5PAqCbG7IJzU0uFVjk4+nSqjTREErkkenegDbkwo78+lEfCliKD83zcf4U4r8u084HFAHl/xb1iTTdRs41bG5Sa89ufE1w0gAkOK77436U17Lp8sQJIyprzdfDl0W3EHFAHWeANfuJ/EdpDvJDHFe2xqxTfgceteKfDHQpIfFEM0gOIwTyK9u+6vHQ9qAIXXge9OWL5A2QecVIq8cDBqQJjHU9hQAxF2rimhec4zU38eOcelG392SoIJPIzQBC3TnIxUbDA6jFTvkEnHHpUTIxXK/hQBTlXqdh/CqBt42HGd1aV2doJzk+grPMrs2FjCmgDeC4wvP1pXGBToueD36UScZ4I44oA5nxZbJcJArKGIY8+lYP8AZyHjYPyrqtYG5VxyQaoCEY5oAh8OWiQ34YAdOwrre3IrE0iMfaMnpW4BxjigAVT/ABD60/ceAVPrntTgp/wpVHy5YHGKAGKfvkHmonmYnCD68d6sxj5V29O+ajxnPy7T6+tAFVmm6Yxn86SXzcctgY7DvViRT/CpY+tIOh6fjQBlMrfMWUmoI42LMFz14OK0X+WRsyDGOOahGzJBb8TQBeDAFevFSOwYfzqsOc88U5PrQBS1RfmXpjPaqg4XtVzVZAGTdx2rOaZP8KANDTNvnc+laqHJ+XjFYunSKz4zzWuh5GTQBYDdMenWhmYKOOM9ahEn7wBSMD0p8jbvvHoaAJcgZPAJqJixY4k49KZJJCqAkg+vFQpNESVRScDsKAJzuHRic9vSomVWJ+Rj6EmomnYPkRH86JJJmTIGM0AK0e1TnYp+lV3aKNsyOHJ7KKkWBiS0hJJ6ZNNNr87d/egCVGBUbRgY54pq444weehpdqhyeuRTCCr7vf0oAxvFFx9nMS7uCe9Ybah83DZAqbx/JJ9ph29Mc1y7yt270Adlot4Gu0HXNdUJMHd/OvMtBuHGoxdQN1ekLgp6jFAEsL8lh61MMMpByeMdagQgD0+lTgKRwpyKAFdFVFGAcVGFXbnAHtUhUMhIPamcMcbjkUALtwMLSg4PPamn5cUx2BGR+FAErFcZ2k0u4Ae/vVCeaQD5FP1J61XwznDyHPoDQBeZt3BGKa33f60dOe/eomagDmfGO3zIt7ce9c44txkbgK1viEJWMJj7GuPMd0WP3hQB0mkLB9siww68Gu9jb5AM8YFeUaGLldSi6n5hnivU4QxhQ8dO9AFtGGOgqYMQp5/OqgD8ZK4qRdzE8jHbigCwDxnsfSkB654qMhRzuFI8gVS24EYoAJJdpPQCopLpfugbj64qrNJ5pyuKSKM7xuPagBZGbJOefSmxnLc8HHFP+XdtKnjqakVUzuXoOuaAJAfl60xiRknNN3Nu4z70vUckmgDF16JZ9uR0rJe0jzwv6Vr6/Ose2sc3iDLFgBQBJY2sa3KNjvXVo21VHtXLWNxG06YIIzXTxDcoNAEy88sf/r1MDwO3FRZCrwMUrOVGRyfSgBZJFXqefSqjF5X6cU50DHc/Sml1HyoCD70AKV8sYWM5o/eMw7YqOSSTIGBimKzMCcEf0oAlLHJ3Pj3pYJGYnLZXtUIPzeoB4zT8KXyM4oAmAOc/5NEpYZwRj9adnEeMgGqtwrcMrN9KAOL+IN/LbvGqbq5I6tcEfdP0rtvFlrHO6+Yv5msEabb9ABwKAK+japM13EDnk16rYNut4z6ivP8AS9NhF3GwA4Ir0O22rEoGRgUASkHA3frTN3P97FNmbJA9aj3lONoAoAdPJ8p5/KoYW3Zb370shLHbg0gxHnof6UAMLMSflAxUckjZAjzk1OmXUblA96NoAJXjNAEEcjZ27SP61IvmHHYDtTki+Y5xT9uzjPFAD3+5UZJPWpQuVDUxlUE+tAHG+MJmjuFHaufF82e+K6/xNZ+eVOOe1YiaUu7GAaADRLlpLyNfeu/jOIgfauN02xWK5RwOhrrhuEYbjOOOaAF8x2IXp7mjv82M9jUWWGD0P51IpLjA/OgBC7Keoz2qNPML7ialWL8TUm0L6ZoAYAdu7k8d6jDNnGMVYDK4x0HrTSqf3qAGRhmbgipEU/xMfrSrtX7opZCAOpH4UAORm2KNnUZ608hSPektvmiX6cVOIi3Kr7UAYesRgAZFZ5RfvcA1b8RSmPcjjBrEiuGPGeBQBdVgsqAZzmtpELxDcx/CuaE3zDufrXSaaN9uCxHI6UABQAlRlifUVNuZRjpQxbJ+X8aMZGRigBQwPVCD65pzxjYW3E0EDPPNKuACOc49aAISNqjDNg9qSMZbLDFKApJ+8KBgHvnPegCcfKvy1GrcksB9KerEds0x23N0oAt23y2yNnnA5qeOZQpRsAZzmqtu6/ZFXvgdaY7AA46UAYPjBvmBU546VzMcuD710XiRfMXvXMvHJxsXgdaAJY5SJ1UjjPfpXbabta0XO0HHGDXERQsZVyuQD6V2OmhVgUjnj8KANE7dnDc/XNNUMec8DtT49ud3FM/5aHpQAP8AdJ5z6CmZOCFY49/Wlb5iecAdamjiTHUk0AQKxA+YE4pC3J+YewpJcKWHLc8VDuXeB0z1oAsK2R6c0meeO1NUDHy9O1BBA6jJoAsR7VUDsBimP1O1j9PSkWXK8KD+NMaVslSgAoAp6nD5qcjNY32Rtwwvfua35VRxksR7Zqs8O5h6elAGatsyMCygD0rZjIWJVznFQlVxgrzUq8Jycj0oAtLJgjpSvhjw3OO1VYyRnpyatEjAPGRQAjnadoz70JLIFI9BikYMcncN1R7Xz1wBQAhbIweuaQbd/JxU21hyGBPvTXK4yQOOpoAYrbGwxB54xTzl8noM1AUZpPlyPSnBjnaTk+1AD4VKRbevvSfMufl5PfNLuwoHrUbmRsjAx2OaAHnt0460hO45ONuKYzP95Rg03LhduCT60ARHzBPIGZfLONgA5Hrk1JuG3rn0pjBi3zHNOwuzGM/SgBU5IHv1q1taNh82frVRSABwQKniYnufzoAkduTxTA5wCy5p/wA3Q/nTcc8HigBCze/rinAZH/1qcsYLdyadI0SD94wGOgFAEQjyd2c1KqxRkliM1n3V9KVKWybc/wARFUjazOoa4nZ3784z+VAGknSh+DuHWiigBsDs2dxzT/4j9KKKAGryOeaGAGCPSiigBB1NOjJx+NFFAD8nd1PSn9h9RRRQBNcsVgBXg4rIdmbqSaKKAD27UHr+FFFAH//Z"/>
          <p:cNvSpPr>
            <a:spLocks noChangeAspect="1" noChangeArrowheads="1"/>
          </p:cNvSpPr>
          <p:nvPr/>
        </p:nvSpPr>
        <p:spPr bwMode="auto">
          <a:xfrm>
            <a:off x="924166" y="2033538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87FC5C3-7675-1E4D-A4DD-DF0FB59EDCB8}"/>
              </a:ext>
            </a:extLst>
          </p:cNvPr>
          <p:cNvSpPr txBox="1"/>
          <p:nvPr/>
        </p:nvSpPr>
        <p:spPr>
          <a:xfrm rot="16200000">
            <a:off x="1475471" y="31634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561F57FA-97EE-AF4B-8E46-310FAD7BB6DF}"/>
              </a:ext>
            </a:extLst>
          </p:cNvPr>
          <p:cNvCxnSpPr/>
          <p:nvPr/>
        </p:nvCxnSpPr>
        <p:spPr>
          <a:xfrm flipH="1">
            <a:off x="2505057" y="3871164"/>
            <a:ext cx="2898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38049E8D-C0B7-B04C-9023-870A5462859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4000" contrast="36000"/>
                    </a14:imgEffect>
                  </a14:imgLayer>
                </a14:imgProps>
              </a:ext>
            </a:extLst>
          </a:blip>
          <a:srcRect l="20669" t="12225" r="57013" b="55659"/>
          <a:stretch/>
        </p:blipFill>
        <p:spPr>
          <a:xfrm>
            <a:off x="1393831" y="3478575"/>
            <a:ext cx="1079488" cy="117700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E561204-E11D-3743-AD00-BB87EBE987A1}"/>
              </a:ext>
            </a:extLst>
          </p:cNvPr>
          <p:cNvSpPr txBox="1"/>
          <p:nvPr/>
        </p:nvSpPr>
        <p:spPr>
          <a:xfrm rot="16200000">
            <a:off x="1132922" y="2317264"/>
            <a:ext cx="2153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v2509-C-terminal truncat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EF5DC4-7F6E-AD4C-BBCB-FE25084D9F57}"/>
              </a:ext>
            </a:extLst>
          </p:cNvPr>
          <p:cNvSpPr txBox="1"/>
          <p:nvPr/>
        </p:nvSpPr>
        <p:spPr>
          <a:xfrm rot="16200000">
            <a:off x="1565159" y="3039686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v250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4EF5DC4-7F6E-AD4C-BBCB-FE25084D9F57}"/>
              </a:ext>
            </a:extLst>
          </p:cNvPr>
          <p:cNvSpPr txBox="1"/>
          <p:nvPr/>
        </p:nvSpPr>
        <p:spPr>
          <a:xfrm rot="16200000">
            <a:off x="4093265" y="3059880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v250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EF5DC4-7F6E-AD4C-BBCB-FE25084D9F57}"/>
              </a:ext>
            </a:extLst>
          </p:cNvPr>
          <p:cNvSpPr txBox="1"/>
          <p:nvPr/>
        </p:nvSpPr>
        <p:spPr>
          <a:xfrm rot="16200000">
            <a:off x="3680212" y="2264105"/>
            <a:ext cx="2319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v2509 + 0.1% Glutaraldehyd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7FC5C3-7675-1E4D-A4DD-DF0FB59EDCB8}"/>
              </a:ext>
            </a:extLst>
          </p:cNvPr>
          <p:cNvSpPr txBox="1"/>
          <p:nvPr/>
        </p:nvSpPr>
        <p:spPr>
          <a:xfrm rot="16200000">
            <a:off x="3907018" y="319174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3" name="AutoShape 6" descr="data:image/jpg;base64,%20/9j/4AAQSkZJRgABAQEAYABgAAD/2wBDAAUDBAQEAwUEBAQFBQUGBwwIBwcHBw8LCwkMEQ8SEhEPERETFhwXExQaFRERGCEYGh0dHx8fExciJCIeJBweHx7/2wBDAQUFBQcGBw4ICA4eFBEUHh4eHh4eHh4eHh4eHh4eHh4eHh4eHh4eHh4eHh4eHh4eHh4eHh4eHh4eHh4eHh4eHh7/wAARCAEDAG8DASIAAhEBAxEB/8QAHwAAAQUBAQEBAQEAAAAAAAAAAAECAwQFBgcICQoL/8QAtRAAAgEDAwIEAwUFBAQAAAF9AQIDAAQRBRIhMUEGE1FhByJxFDKBkaEII0KxwRVS0fAkM2JyggkKFhcYGRolJicoKSo0NTY3ODk6Q0RFRkdISUpTVFVWV1hZWmNkZWZnaGlqc3R1dnd4eXqDhIWGh4iJipKTlJWWl5iZmqKjpKWmp6ipqrKztLW2t7i5usLDxMXGx8jJytLT1NXW19jZ2uHi4+Tl5ufo6erx8vP09fb3+Pn6/8QAHwEAAwEBAQEBAQEBAQAAAAAAAAECAwQFBgcICQoL/8QAtREAAgECBAQDBAcFBAQAAQJ3AAECAxEEBSExBhJBUQdhcRMiMoEIFEKRobHBCSMzUvAVYnLRChYkNOEl8RcYGRomJygpKjU2Nzg5OkNERUZHSElKU1RVVldYWVpjZGVmZ2hpanN0dXZ3eHl6goOEhYaHiImKkpOUlZaXmJmaoqOkpaanqKmqsrO0tba3uLm6wsPExcbHyMnK0tPU1dbX2Nna4uPk5ebn6Onq8vP09fb3+Pn6/9oADAMBAAIRAxEAPwDpPvKOvWpCvTI49aB0ApyBt2CaAFyvA64pMCmOQJMcd6aHKnqaAJdo3cYpkiZyDjrT0VmzziiTIHGfegCB4dx9PWljhxxjNTRksp6kD2qaJgFK7evegCrsYMT2qSMFjzwuc1KU6gd+ntSr34H1oAgvXCxnZHvB6gVVhdDjb8uR3qwXZi5O373b0qJo/MYnI9sDFADZFUA56+4rPu9iuCqkZ61ouAExk5xwfeqEzKzbW4agDWA2ruP51Ki/xDmmMRwvSlyfUD1xQBBcsPNXPYc1GJF3DGK5Xxtquq2WrxQWNm80bQ7gw9c1g/2p4sY7vsBFAHq1jtYFuvanSJ/CPxrn/AN5qF3Zzm/t2hdWwM9+K6HvkH86AGrFg4wOTT8FeeMdqUMPxpkjgdOcUAO4Y4zSNjaV4pIzn5u9BzgmgCuUQsSeT1pEUjJPc1M0Y3YznNMlyPp2oArzZDAgbhVCWGSW4DBQODk1oSsO2c9qrknccZNAF8qcdzSADbVg8jaRioiAM7TkUAZ16qtdAMuQF60z92w4wR2rC8aaxLpupxRhCUkiyG981j23irEm1gQDQB6NpeBCduBzVplGB2rA8I6nHqCTbP4MZreclY8jqehNAD4XhST95zjtUV5JHMwEa7QO470LEu3PVjycioTFg7gcHtQBPCvJxx6CmyOsfysRmrFqvyqc9vSoCgaV2wG+tADCV+Zi2cdKhlmjZgisM1IYUGBj3qvOo3Zxg9uKAEdTndgGo5Nqj5up9BVshcDuahm+8TjP4UAX/vHnpTGQHvj8KlVT6ZBqQKpYHuKAMDxJp8Fy0XmIrFQRyK5+XQrPPzQD8K6bXJkjePcwBOazJLyHoXWgCXwpY29k8ywjG8AmujZeFB6isLR7iOS6GGHPpW4QzKdrAUAKWxH834VCi5POOKWTcMZ5ApsYOD2XvQBbjGF701FOfm7mnKWbaw4VR0pHfaCB1oACq4IIzVOdfnAFWHMmAMc1EwZh8w5oAiHB5PAqCbG7IJzU0uFVjk4+nSqjTREErkkenegDbkwo78+lEfCliKD83zcf4U4r8u084HFAHl/xb1iTTdRs41bG5Sa89ufE1w0gAkOK77436U17Lp8sQJIyprzdfDl0W3EHFAHWeANfuJ/EdpDvJDHFe2xqxTfgceteKfDHQpIfFEM0gOIwTyK9u+6vHQ9qAIXXge9OWL5A2QecVIq8cDBqQJjHU9hQAxF2rimhec4zU38eOcelG392SoIJPIzQBC3TnIxUbDA6jFTvkEnHHpUTIxXK/hQBTlXqdh/CqBt42HGd1aV2doJzk+grPMrs2FjCmgDeC4wvP1pXGBToueD36UScZ4I44oA5nxZbJcJArKGIY8+lYP8AZyHjYPyrqtYG5VxyQaoCEY5oAh8OWiQ34YAdOwrre3IrE0iMfaMnpW4BxjigAVT/ABD60/ceAVPrntTgp/wpVHy5YHGKAGKfvkHmonmYnCD68d6sxj5V29O+ajxnPy7T6+tAFVmm6Yxn86SXzcctgY7DvViRT/CpY+tIOh6fjQBlMrfMWUmoI42LMFz14OK0X+WRsyDGOOahGzJBb8TQBeDAFevFSOwYfzqsOc88U5PrQBS1RfmXpjPaqg4XtVzVZAGTdx2rOaZP8KANDTNvnc+laqHJ+XjFYunSKz4zzWuh5GTQBYDdMenWhmYKOOM9ahEn7wBSMD0p8jbvvHoaAJcgZPAJqJixY4k49KZJJCqAkg+vFQpNESVRScDsKAJzuHRic9vSomVWJ+Rj6EmomnYPkRH86JJJmTIGM0AK0e1TnYp+lV3aKNsyOHJ7KKkWBiS0hJJ6ZNNNr87d/egCVGBUbRgY54pq444weehpdqhyeuRTCCr7vf0oAxvFFx9nMS7uCe9Ybah83DZAqbx/JJ9ph29Mc1y7yt270Adlot4Gu0HXNdUJMHd/OvMtBuHGoxdQN1ekLgp6jFAEsL8lh61MMMpByeMdagQgD0+lTgKRwpyKAFdFVFGAcVGFXbnAHtUhUMhIPamcMcbjkUALtwMLSg4PPamn5cUx2BGR+FAErFcZ2k0u4Ae/vVCeaQD5FP1J61XwznDyHPoDQBeZt3BGKa33f60dOe/eomagDmfGO3zIt7ce9c44txkbgK1viEJWMJj7GuPMd0WP3hQB0mkLB9siww68Gu9jb5AM8YFeUaGLldSi6n5hnivU4QxhQ8dO9AFtGGOgqYMQp5/OqgD8ZK4qRdzE8jHbigCwDxnsfSkB654qMhRzuFI8gVS24EYoAJJdpPQCopLpfugbj64qrNJ5pyuKSKM7xuPagBZGbJOefSmxnLc8HHFP+XdtKnjqakVUzuXoOuaAJAfl60xiRknNN3Nu4z70vUckmgDF16JZ9uR0rJe0jzwv6Vr6/Ose2sc3iDLFgBQBJY2sa3KNjvXVo21VHtXLWNxG06YIIzXTxDcoNAEy88sf/r1MDwO3FRZCrwMUrOVGRyfSgBZJFXqefSqjF5X6cU50DHc/Sml1HyoCD70AKV8sYWM5o/eMw7YqOSSTIGBimKzMCcEf0oAlLHJ3Pj3pYJGYnLZXtUIPzeoB4zT8KXyM4oAmAOc/5NEpYZwRj9adnEeMgGqtwrcMrN9KAOL+IN/LbvGqbq5I6tcEfdP0rtvFlrHO6+Yv5msEabb9ABwKAK+japM13EDnk16rYNut4z6ivP8AS9NhF3GwA4Ir0O22rEoGRgUASkHA3frTN3P97FNmbJA9aj3lONoAoAdPJ8p5/KoYW3Zb370shLHbg0gxHnof6UAMLMSflAxUckjZAjzk1OmXUblA96NoAJXjNAEEcjZ27SP61IvmHHYDtTki+Y5xT9uzjPFAD3+5UZJPWpQuVDUxlUE+tAHG+MJmjuFHaufF82e+K6/xNZ+eVOOe1YiaUu7GAaADRLlpLyNfeu/jOIgfauN02xWK5RwOhrrhuEYbjOOOaAF8x2IXp7mjv82M9jUWWGD0P51IpLjA/OgBC7Keoz2qNPML7ialWL8TUm0L6ZoAYAdu7k8d6jDNnGMVYDK4x0HrTSqf3qAGRhmbgipEU/xMfrSrtX7opZCAOpH4UAORm2KNnUZ608hSPektvmiX6cVOIi3Kr7UAYesRgAZFZ5RfvcA1b8RSmPcjjBrEiuGPGeBQBdVgsqAZzmtpELxDcx/CuaE3zDufrXSaaN9uCxHI6UABQAlRlifUVNuZRjpQxbJ+X8aMZGRigBQwPVCD65pzxjYW3E0EDPPNKuACOc49aAISNqjDNg9qSMZbLDFKApJ+8KBgHvnPegCcfKvy1GrcksB9KerEds0x23N0oAt23y2yNnnA5qeOZQpRsAZzmqtu6/ZFXvgdaY7AA46UAYPjBvmBU546VzMcuD710XiRfMXvXMvHJxsXgdaAJY5SJ1UjjPfpXbabta0XO0HHGDXERQsZVyuQD6V2OmhVgUjnj8KANE7dnDc/XNNUMec8DtT49ud3FM/5aHpQAP8AdJ5z6CmZOCFY49/Wlb5iecAdamjiTHUk0AQKxA+YE4pC3J+YewpJcKWHLc8VDuXeB0z1oAsK2R6c0meeO1NUDHy9O1BBA6jJoAsR7VUDsBimP1O1j9PSkWXK8KD+NMaVslSgAoAp6nD5qcjNY32Rtwwvfua35VRxksR7Zqs8O5h6elAGatsyMCygD0rZjIWJVznFQlVxgrzUq8Jycj0oAtLJgjpSvhjw3OO1VYyRnpyatEjAPGRQAjnadoz70JLIFI9BikYMcncN1R7Xz1wBQAhbIweuaQbd/JxU21hyGBPvTXK4yQOOpoAYrbGwxB54xTzl8noM1AUZpPlyPSnBjnaTk+1AD4VKRbevvSfMufl5PfNLuwoHrUbmRsjAx2OaAHnt0460hO45ONuKYzP95Rg03LhduCT60ARHzBPIGZfLONgA5Hrk1JuG3rn0pjBi3zHNOwuzGM/SgBU5IHv1q1taNh82frVRSABwQKniYnufzoAkduTxTA5wCy5p/wA3Q/nTcc8HigBCze/rinAZH/1qcsYLdyadI0SD94wGOgFAEQjyd2c1KqxRkliM1n3V9KVKWybc/wARFUjazOoa4nZ3784z+VAGknSh+DuHWiigBsDs2dxzT/4j9KKKAGryOeaGAGCPSiigBB1NOjJx+NFFAD8nd1PSn9h9RRRQBNcsVgBXg4rIdmbqSaKKAD27UHr+FFFAH//Z"/>
          <p:cNvSpPr>
            <a:spLocks noChangeAspect="1" noChangeArrowheads="1"/>
          </p:cNvSpPr>
          <p:nvPr/>
        </p:nvSpPr>
        <p:spPr bwMode="auto">
          <a:xfrm>
            <a:off x="3293189" y="2051744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F7D7706-9456-D247-9F9E-089F990ABFFF}"/>
              </a:ext>
            </a:extLst>
          </p:cNvPr>
          <p:cNvSpPr txBox="1"/>
          <p:nvPr/>
        </p:nvSpPr>
        <p:spPr>
          <a:xfrm>
            <a:off x="3505877" y="3522686"/>
            <a:ext cx="433132" cy="2092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E583E6BF-E3F8-4A44-AC04-1137E8C4CEF7}"/>
              </a:ext>
            </a:extLst>
          </p:cNvPr>
          <p:cNvCxnSpPr/>
          <p:nvPr/>
        </p:nvCxnSpPr>
        <p:spPr>
          <a:xfrm flipH="1">
            <a:off x="5035080" y="4655580"/>
            <a:ext cx="2898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D3282982-C8B4-D84A-890F-0587F96DC992}"/>
              </a:ext>
            </a:extLst>
          </p:cNvPr>
          <p:cNvSpPr txBox="1"/>
          <p:nvPr/>
        </p:nvSpPr>
        <p:spPr>
          <a:xfrm>
            <a:off x="5324971" y="4517080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~32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A03692-F94A-44A0-BEA3-325C11943FED}"/>
              </a:ext>
            </a:extLst>
          </p:cNvPr>
          <p:cNvSpPr txBox="1"/>
          <p:nvPr/>
        </p:nvSpPr>
        <p:spPr>
          <a:xfrm>
            <a:off x="240887" y="291037"/>
            <a:ext cx="6349901" cy="141577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600" dirty="0">
                <a:latin typeface="Arial"/>
                <a:cs typeface="Arial"/>
              </a:rPr>
              <a:t>Supporting information Fig.5</a:t>
            </a:r>
          </a:p>
          <a:p>
            <a:pPr algn="just"/>
            <a:r>
              <a:rPr lang="en-US" sz="1400" dirty="0">
                <a:latin typeface="Arial"/>
                <a:cs typeface="Arial"/>
              </a:rPr>
              <a:t>Analysis of full length and C-terminal truncated Rv2509 by Native PAGE (A) and glutaraldehyde crosslinking (B).  (A) shows a western blot of the Native gel and (B) shows SDS PAGE of untreated and glutaraldehyde treated Rv2509. M; </a:t>
            </a:r>
            <a:r>
              <a:rPr lang="en-US" sz="1400" dirty="0" err="1">
                <a:latin typeface="Arial"/>
                <a:cs typeface="Arial"/>
              </a:rPr>
              <a:t>PageRuler</a:t>
            </a:r>
            <a:r>
              <a:rPr lang="en-US" sz="1400" dirty="0">
                <a:latin typeface="Arial"/>
                <a:cs typeface="Arial"/>
              </a:rPr>
              <a:t>™ </a:t>
            </a:r>
            <a:r>
              <a:rPr lang="en-US" sz="1400" dirty="0" err="1">
                <a:latin typeface="Arial"/>
                <a:cs typeface="Arial"/>
              </a:rPr>
              <a:t>Prestained</a:t>
            </a:r>
            <a:r>
              <a:rPr lang="en-US" sz="1400" dirty="0">
                <a:latin typeface="Arial"/>
                <a:cs typeface="Arial"/>
              </a:rPr>
              <a:t> Protein Ladder (</a:t>
            </a:r>
            <a:r>
              <a:rPr lang="en-US" sz="1400" dirty="0" err="1">
                <a:latin typeface="Arial"/>
                <a:cs typeface="Arial"/>
              </a:rPr>
              <a:t>Thermo</a:t>
            </a:r>
            <a:r>
              <a:rPr lang="en-US" sz="1400" dirty="0">
                <a:latin typeface="Arial"/>
                <a:cs typeface="Arial"/>
              </a:rPr>
              <a:t> Fisher Scientific). Sizes are indicated in (B).</a:t>
            </a:r>
          </a:p>
        </p:txBody>
      </p:sp>
    </p:spTree>
    <p:extLst>
      <p:ext uri="{BB962C8B-B14F-4D97-AF65-F5344CB8AC3E}">
        <p14:creationId xmlns:p14="http://schemas.microsoft.com/office/powerpoint/2010/main" val="31637986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8F2A6CDD-BA74-2543-BEF1-CBBF3B9E95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474" y="79013"/>
            <a:ext cx="6305550" cy="28007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Times New Roman"/>
              </a:rPr>
              <a:t>Supporting Information Fig.</a:t>
            </a:r>
            <a:r>
              <a:rPr lang="en-US" altLang="en-US" sz="1600" dirty="0">
                <a:latin typeface="Arial"/>
                <a:ea typeface="Calibri" panose="020F0502020204030204" pitchFamily="34" charset="0"/>
                <a:cs typeface="Times New Roman"/>
              </a:rPr>
              <a:t>6 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Generation of a conditional 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M. </a:t>
            </a:r>
            <a:r>
              <a:rPr kumimoji="0" lang="en-US" altLang="en-US" sz="1600" b="0" i="1" u="none" strike="noStrike" cap="none" normalizeH="0" baseline="0" dirty="0" err="1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bovis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 BCG-Pasteur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 BCG_2529 mutant.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effectLst/>
              <a:latin typeface="Arial"/>
              <a:cs typeface="Arial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(A) Organization of the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BCG_2529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 locus in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M. </a:t>
            </a:r>
            <a:r>
              <a:rPr kumimoji="0" lang="en-US" altLang="en-US" sz="1400" b="0" i="1" u="none" strike="noStrike" cap="none" normalizeH="0" baseline="0" dirty="0" err="1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bovis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 BCG-Pasteur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 wild-type as well as in a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BCG_2529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conditional mutant. The sizes of relevant fragments as well as the location of the oligonucleotides used for diagnostic PCR are indicated. WT, wild-type; </a:t>
            </a: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fw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, oligonucleotide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BCG_2529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_L_fw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; rev, </a:t>
            </a: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oligonucleotid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BCG_2529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_L_rev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; </a:t>
            </a: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hyg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,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hygromycin resistance gene.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 (B) Diagnostic PCR of genomic DNA using oligonucleotides binding to the position indicated in A, showing the insertion of a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synthetic gene cassette (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hyg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-P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myc1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-4X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tetO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) that contained a duplication of 66 bp of the 5´-end of </a:t>
            </a:r>
            <a:r>
              <a:rPr kumimoji="0" lang="en-US" altLang="en-US" sz="1400" b="0" i="1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BCG_2529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effectLst/>
                <a:latin typeface="Arial"/>
                <a:ea typeface="Calibri" panose="020F0502020204030204" pitchFamily="34" charset="0"/>
                <a:cs typeface="Arial"/>
              </a:rPr>
              <a:t>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effectLst/>
              <a:latin typeface="Arial"/>
              <a:cs typeface="Arial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5" name="Grafik 10" descr="Fig.1 (1)">
            <a:extLst>
              <a:ext uri="{FF2B5EF4-FFF2-40B4-BE49-F238E27FC236}">
                <a16:creationId xmlns:a16="http://schemas.microsoft.com/office/drawing/2014/main" id="{FBDA9A1E-F1DD-FA4D-BD3B-8BC1487126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450" y="3463871"/>
            <a:ext cx="5753100" cy="402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DB7A0960-3241-8D4B-A4CC-F98772C5DA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4831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823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0</TotalTime>
  <Words>253</Words>
  <Application>Microsoft Macintosh PowerPoint</Application>
  <PresentationFormat>A4 Paper (210x297 mm)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l singh</dc:creator>
  <cp:lastModifiedBy>Microsoft Office User</cp:lastModifiedBy>
  <cp:revision>65</cp:revision>
  <dcterms:created xsi:type="dcterms:W3CDTF">2018-05-01T09:51:13Z</dcterms:created>
  <dcterms:modified xsi:type="dcterms:W3CDTF">2019-11-11T10:17:43Z</dcterms:modified>
</cp:coreProperties>
</file>